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4" d="100"/>
          <a:sy n="94" d="100"/>
        </p:scale>
        <p:origin x="-461" y="5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F85C4-A4E6-4350-8D78-1CB0AF949E78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FFF02-4339-4994-B717-E9A56A6E8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1401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F85C4-A4E6-4350-8D78-1CB0AF949E78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FFF02-4339-4994-B717-E9A56A6E8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9603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F85C4-A4E6-4350-8D78-1CB0AF949E78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FFF02-4339-4994-B717-E9A56A6E8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6220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F85C4-A4E6-4350-8D78-1CB0AF949E78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FFF02-4339-4994-B717-E9A56A6E8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3379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F85C4-A4E6-4350-8D78-1CB0AF949E78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FFF02-4339-4994-B717-E9A56A6E8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6683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F85C4-A4E6-4350-8D78-1CB0AF949E78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FFF02-4339-4994-B717-E9A56A6E8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1936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F85C4-A4E6-4350-8D78-1CB0AF949E78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FFF02-4339-4994-B717-E9A56A6E8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14780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F85C4-A4E6-4350-8D78-1CB0AF949E78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FFF02-4339-4994-B717-E9A56A6E8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55202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F85C4-A4E6-4350-8D78-1CB0AF949E78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FFF02-4339-4994-B717-E9A56A6E8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7789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F85C4-A4E6-4350-8D78-1CB0AF949E78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FFF02-4339-4994-B717-E9A56A6E8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629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F85C4-A4E6-4350-8D78-1CB0AF949E78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4FFF02-4339-4994-B717-E9A56A6E8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7177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BF85C4-A4E6-4350-8D78-1CB0AF949E78}" type="datetimeFigureOut">
              <a:rPr kumimoji="1" lang="ja-JP" altLang="en-US" smtClean="0"/>
              <a:t>2020/9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4FFF02-4339-4994-B717-E9A56A6E85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5205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238154" y="161417"/>
            <a:ext cx="19255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dditional file 2</a:t>
            </a:r>
            <a:endParaRPr kumimoji="1" lang="ja-JP" altLang="en-US" sz="2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846" y="1916832"/>
            <a:ext cx="8654125" cy="21252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正方形/長方形 5"/>
          <p:cNvSpPr/>
          <p:nvPr/>
        </p:nvSpPr>
        <p:spPr>
          <a:xfrm>
            <a:off x="338828" y="4061150"/>
            <a:ext cx="852984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Forest plot in comparing hospital mortality between prolonged and intermittent infusion strategy of  published year &lt;2015 in sepsis or septic shock. M–H, Mantel–</a:t>
            </a:r>
            <a:r>
              <a:rPr lang="en-US" altLang="ja-JP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Haenszel</a:t>
            </a:r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; CI, confidence interval.</a:t>
            </a:r>
            <a:endParaRPr lang="ja-JP" altLang="ja-JP" dirty="0" smtClean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22846" y="1155919"/>
            <a:ext cx="526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A)</a:t>
            </a:r>
            <a:endParaRPr kumimoji="1" lang="ja-JP" altLang="en-US" sz="2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2766908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38154" y="161417"/>
            <a:ext cx="19255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7227" y="1916832"/>
            <a:ext cx="8766224" cy="20882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テキスト ボックス 5"/>
          <p:cNvSpPr txBox="1"/>
          <p:nvPr/>
        </p:nvSpPr>
        <p:spPr>
          <a:xfrm>
            <a:off x="222846" y="1155919"/>
            <a:ext cx="5261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351770" y="4084524"/>
            <a:ext cx="852984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Forest plot in comparing hospital mortality between prolonged and intermittent infusion strategy of  published year ≥2015 in sepsis or septic shock. M–H, Mantel–</a:t>
            </a:r>
            <a:r>
              <a:rPr lang="en-US" altLang="ja-JP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Haenszel</a:t>
            </a:r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; CI, confidence interval.</a:t>
            </a:r>
            <a:endParaRPr lang="ja-JP" altLang="ja-JP" dirty="0" smtClean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1264977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238154" y="161417"/>
            <a:ext cx="19255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dditional file 2</a:t>
            </a:r>
            <a:endParaRPr kumimoji="1" lang="ja-JP" altLang="en-US" sz="2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251520" y="4084524"/>
            <a:ext cx="871296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Forest plot in comparing clinical cure between prolonged and intermittent infusion strategy of  published year &lt;2015 in sepsis or septic shock. M–H, Mantel–</a:t>
            </a:r>
            <a:r>
              <a:rPr lang="en-US" altLang="ja-JP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Haenszel</a:t>
            </a:r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; CI, confidence interval.</a:t>
            </a:r>
            <a:endParaRPr lang="ja-JP" altLang="ja-JP" dirty="0" smtClean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22846" y="1155919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C)</a:t>
            </a:r>
            <a:endParaRPr kumimoji="1" lang="ja-JP" altLang="en-US" sz="2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846" y="1765364"/>
            <a:ext cx="8651612" cy="23837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498727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238154" y="161417"/>
            <a:ext cx="19255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2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22846" y="1155919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238154" y="4084524"/>
            <a:ext cx="872633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Forest plot in comparing clinical cure between prolonged and intermittent infusion strategy of  published year ≥2015 in sepsis or septic shock. M–H, Mantel–</a:t>
            </a:r>
            <a:r>
              <a:rPr lang="en-US" altLang="ja-JP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Haenszel</a:t>
            </a:r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; CI, confidence interval.</a:t>
            </a:r>
            <a:endParaRPr lang="ja-JP" altLang="ja-JP" dirty="0" smtClean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853" y="1948009"/>
            <a:ext cx="8836936" cy="19130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49872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</TotalTime>
  <Words>152</Words>
  <Application>Microsoft Office PowerPoint</Application>
  <PresentationFormat>画面に合わせる (4:3)</PresentationFormat>
  <Paragraphs>12</Paragraphs>
  <Slides>4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5" baseType="lpstr"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救急医療講座Z０２</dc:creator>
  <cp:lastModifiedBy>救急医療講座Z０２</cp:lastModifiedBy>
  <cp:revision>10</cp:revision>
  <dcterms:created xsi:type="dcterms:W3CDTF">2020-05-27T02:39:08Z</dcterms:created>
  <dcterms:modified xsi:type="dcterms:W3CDTF">2020-09-03T02:02:48Z</dcterms:modified>
</cp:coreProperties>
</file>